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AB7785-48CF-4E7C-A66A-F69B51C050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DBCBD-FAA0-41C6-A18F-519CED4668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91F94-F0E9-4916-9604-4F0BCFE965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9F780-0507-4415-BEAB-7D0373B6C1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767F9-B97B-491B-BD5B-01801B7ABD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B7D7F-2A55-461F-A1BF-58A2B1A1F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764A3-F2C9-4566-8234-AD8187DBC0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B0FE0-1D07-492B-9918-CA59290A73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17D88-7BC5-47FF-9E0B-406F294682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36552-FDF7-499C-B3E2-EDC3E02387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C1C8B-C2EC-4838-97CA-85A51B65FF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86D54-9C2C-4C36-9C65-B204ACF0B0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EF2F0A-815B-40EF-8C49-CCA7E4D36E4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36600" y="135000"/>
          <a:ext cx="3357720" cy="6041880"/>
        </p:xfrm>
        <a:graphic>
          <a:graphicData uri="http://schemas.openxmlformats.org/drawingml/2006/table">
            <a:tbl>
              <a:tblPr/>
              <a:tblGrid>
                <a:gridCol w="588960"/>
                <a:gridCol w="568440"/>
                <a:gridCol w="782640"/>
                <a:gridCol w="701640"/>
                <a:gridCol w="716040"/>
              </a:tblGrid>
              <a:tr h="2872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60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3f57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70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I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d54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4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F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45e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9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F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1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HG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5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Y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00a0a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7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42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I4K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0303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0404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8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RGG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345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59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94d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74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N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48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6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RI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d6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2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04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R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5d83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08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R413-P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74b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93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R413-T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74a5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53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K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344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7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K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35d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893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62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K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344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75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PK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3f56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44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6f9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53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P707A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6a96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95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HA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4965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2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35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33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R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86b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52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d53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8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45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78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67a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04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e6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61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a67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4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89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BW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84c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32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R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50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6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lS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10b0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0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P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a67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0c0c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2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P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74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AI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0a0a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27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A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059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75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AB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059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24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e55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18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-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0c0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5273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45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VA22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344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67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A4-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709f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A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345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3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TP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48e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661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784b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3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T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83b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25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29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KR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0c0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32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RD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4f6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8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LP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447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4763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0c0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35c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1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0909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5643720" y="122400"/>
          <a:ext cx="3443040" cy="6143400"/>
        </p:xfrm>
        <a:graphic>
          <a:graphicData uri="http://schemas.openxmlformats.org/drawingml/2006/table">
            <a:tbl>
              <a:tblPr/>
              <a:tblGrid>
                <a:gridCol w="642960"/>
                <a:gridCol w="633240"/>
                <a:gridCol w="799920"/>
                <a:gridCol w="716040"/>
                <a:gridCol w="650880"/>
              </a:tblGrid>
              <a:tr h="2872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10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0c0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62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0b0b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62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a7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35c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85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5273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72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506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26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55f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6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0b0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a7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28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0a0a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91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CED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0b0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15a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5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HL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0b0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87c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24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Z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e6d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6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0a0a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77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P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0b0b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22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560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68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IP2;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0a0a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86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C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4763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272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73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B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4f6e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54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YL5/RCAR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77a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3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YL9/RCA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b80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6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B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55f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486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CK1B_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0a0a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8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CK1C_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0a0a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32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V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058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33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D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5476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23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D29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66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DU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e56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5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DUF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25c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20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C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548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0a0a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55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19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85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RK2.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547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8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RK2.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45f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18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YP1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447"/>
                    </a:solidFill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77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35d"/>
                    </a:solidFill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1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87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e56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6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0b0b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59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2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4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07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GT72E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0c0c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e55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2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AMP7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35d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45f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02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5070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8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679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b80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82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AT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548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4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F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a67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95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F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77a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3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3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b50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38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38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71a1"/>
                    </a:solidFill>
                  </a:tcPr>
                </a:tc>
              </a:tr>
              <a:tr h="10980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8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8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171"/>
                    </a:solidFill>
                  </a:tcPr>
                </a:tc>
              </a:tr>
              <a:tr h="11088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7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7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74a"/>
                    </a:solidFill>
                  </a:tcPr>
                </a:tc>
              </a:tr>
              <a:tr h="1094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90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90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16088"/>
                    </a:solidFill>
                  </a:tcPr>
                </a:tc>
              </a:tr>
              <a:tr h="111240"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47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47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679"/>
                    </a:solidFill>
                  </a:tcPr>
                </a:tc>
              </a:tr>
            </a:tbl>
          </a:graphicData>
        </a:graphic>
      </p:graphicFrame>
      <p:grpSp>
        <p:nvGrpSpPr>
          <p:cNvPr id="43" name="Gruppieren 4"/>
          <p:cNvGrpSpPr/>
          <p:nvPr/>
        </p:nvGrpSpPr>
        <p:grpSpPr>
          <a:xfrm>
            <a:off x="2087640" y="6234120"/>
            <a:ext cx="2238120" cy="401400"/>
            <a:chOff x="2087640" y="6234120"/>
            <a:chExt cx="2238120" cy="401400"/>
          </a:xfrm>
        </p:grpSpPr>
        <p:grpSp>
          <p:nvGrpSpPr>
            <p:cNvPr id="44" name="Gruppieren 4"/>
            <p:cNvGrpSpPr/>
            <p:nvPr/>
          </p:nvGrpSpPr>
          <p:grpSpPr>
            <a:xfrm>
              <a:off x="2165760" y="6234120"/>
              <a:ext cx="2160000" cy="215640"/>
              <a:chOff x="2165760" y="6234120"/>
              <a:chExt cx="2160000" cy="215640"/>
            </a:xfrm>
          </p:grpSpPr>
          <p:pic>
            <p:nvPicPr>
              <p:cNvPr id="45" name="Grafik 1" descr=""/>
              <p:cNvPicPr/>
              <p:nvPr/>
            </p:nvPicPr>
            <p:blipFill>
              <a:blip r:embed="rId1"/>
              <a:stretch/>
            </p:blipFill>
            <p:spPr>
              <a:xfrm>
                <a:off x="2165760" y="6284880"/>
                <a:ext cx="1134360" cy="15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feld 2"/>
              <p:cNvSpPr/>
              <p:nvPr/>
            </p:nvSpPr>
            <p:spPr>
              <a:xfrm>
                <a:off x="3269160" y="6234120"/>
                <a:ext cx="1056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7" name="Textfeld 2"/>
            <p:cNvSpPr/>
            <p:nvPr/>
          </p:nvSpPr>
          <p:spPr>
            <a:xfrm>
              <a:off x="3121200" y="635904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7"/>
            <p:cNvSpPr/>
            <p:nvPr/>
          </p:nvSpPr>
          <p:spPr>
            <a:xfrm>
              <a:off x="2087640" y="634680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9" name="Textfeld 2"/>
          <p:cNvSpPr/>
          <p:nvPr/>
        </p:nvSpPr>
        <p:spPr>
          <a:xfrm>
            <a:off x="196920" y="220680"/>
            <a:ext cx="89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.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4T15:53:48Z</dcterms:created>
  <dc:creator>Hossein</dc:creator>
  <dc:description/>
  <dc:language>en-US</dc:language>
  <cp:lastModifiedBy>Hossein</cp:lastModifiedBy>
  <dcterms:modified xsi:type="dcterms:W3CDTF">2020-03-20T15:32:33Z</dcterms:modified>
  <cp:revision>5</cp:revision>
  <dc:subject/>
  <dc:title>PowerPoint-Präsentation</dc:title>
</cp:coreProperties>
</file>